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5" r:id="rId3"/>
    <p:sldId id="264" r:id="rId4"/>
    <p:sldId id="26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F6F38B0-1453-DF4C-881E-990FE459E22E}" v="488" dt="2025-06-19T04:56:42.1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83"/>
    <p:restoredTop sz="94898"/>
  </p:normalViewPr>
  <p:slideViewPr>
    <p:cSldViewPr snapToGrid="0" showGuides="1">
      <p:cViewPr>
        <p:scale>
          <a:sx n="134" d="100"/>
          <a:sy n="134" d="100"/>
        </p:scale>
        <p:origin x="144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iming Xu" userId="e18c41139f0e09dd" providerId="LiveId" clId="{7F6F38B0-1453-DF4C-881E-990FE459E22E}"/>
    <pc:docChg chg="undo redo custSel modSld">
      <pc:chgData name="Caiming Xu" userId="e18c41139f0e09dd" providerId="LiveId" clId="{7F6F38B0-1453-DF4C-881E-990FE459E22E}" dt="2025-06-19T04:56:42.132" v="459" actId="18331"/>
      <pc:docMkLst>
        <pc:docMk/>
      </pc:docMkLst>
      <pc:sldChg chg="addSp delSp modSp mod">
        <pc:chgData name="Caiming Xu" userId="e18c41139f0e09dd" providerId="LiveId" clId="{7F6F38B0-1453-DF4C-881E-990FE459E22E}" dt="2025-06-19T04:56:42.132" v="459" actId="18331"/>
        <pc:sldMkLst>
          <pc:docMk/>
          <pc:sldMk cId="2132240086" sldId="256"/>
        </pc:sldMkLst>
        <pc:spChg chg="mod topLvl">
          <ac:chgData name="Caiming Xu" userId="e18c41139f0e09dd" providerId="LiveId" clId="{7F6F38B0-1453-DF4C-881E-990FE459E22E}" dt="2025-06-19T04:54:20.101" v="405" actId="1038"/>
          <ac:spMkLst>
            <pc:docMk/>
            <pc:sldMk cId="2132240086" sldId="256"/>
            <ac:spMk id="7" creationId="{83459769-DAEA-DFB0-7F30-5A84222B8032}"/>
          </ac:spMkLst>
        </pc:spChg>
        <pc:spChg chg="mod topLvl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8" creationId="{461DFD30-ED25-8967-33C7-E34ACFBF846E}"/>
          </ac:spMkLst>
        </pc:spChg>
        <pc:spChg chg="mod topLvl">
          <ac:chgData name="Caiming Xu" userId="e18c41139f0e09dd" providerId="LiveId" clId="{7F6F38B0-1453-DF4C-881E-990FE459E22E}" dt="2025-06-19T04:54:38.854" v="432" actId="553"/>
          <ac:spMkLst>
            <pc:docMk/>
            <pc:sldMk cId="2132240086" sldId="256"/>
            <ac:spMk id="12" creationId="{0BEA0B48-CDC9-2EFD-07B1-39E0462503D0}"/>
          </ac:spMkLst>
        </pc:spChg>
        <pc:spChg chg="mod topLvl">
          <ac:chgData name="Caiming Xu" userId="e18c41139f0e09dd" providerId="LiveId" clId="{7F6F38B0-1453-DF4C-881E-990FE459E22E}" dt="2025-06-19T04:54:38.854" v="432" actId="553"/>
          <ac:spMkLst>
            <pc:docMk/>
            <pc:sldMk cId="2132240086" sldId="256"/>
            <ac:spMk id="16" creationId="{980BAC4B-4EA8-CA5D-FE28-5D48DBE73DAB}"/>
          </ac:spMkLst>
        </pc:spChg>
        <pc:spChg chg="mod topLvl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19" creationId="{82C7E0BE-0499-B8B2-C350-7C1538806105}"/>
          </ac:spMkLst>
        </pc:spChg>
        <pc:spChg chg="mod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22" creationId="{D638EF77-7055-71DF-F03F-0C1F4E3F84A4}"/>
          </ac:spMkLst>
        </pc:spChg>
        <pc:spChg chg="mod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23" creationId="{9555B4E8-5C4D-739A-8B43-4DFBCD3985B4}"/>
          </ac:spMkLst>
        </pc:spChg>
        <pc:spChg chg="mod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24" creationId="{BF9B9C9F-4A35-4592-B459-3B0066983B6B}"/>
          </ac:spMkLst>
        </pc:spChg>
        <pc:spChg chg="mod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25" creationId="{3C4F48F5-D522-D931-BB49-81052E46CD42}"/>
          </ac:spMkLst>
        </pc:spChg>
        <pc:spChg chg="mod topLvl">
          <ac:chgData name="Caiming Xu" userId="e18c41139f0e09dd" providerId="LiveId" clId="{7F6F38B0-1453-DF4C-881E-990FE459E22E}" dt="2025-06-19T04:54:02.832" v="377" actId="165"/>
          <ac:spMkLst>
            <pc:docMk/>
            <pc:sldMk cId="2132240086" sldId="256"/>
            <ac:spMk id="45" creationId="{EB9EC63A-2F6F-007D-0679-39E0F6327DEA}"/>
          </ac:spMkLst>
        </pc:spChg>
        <pc:picChg chg="add mod modCrop">
          <ac:chgData name="Caiming Xu" userId="e18c41139f0e09dd" providerId="LiveId" clId="{7F6F38B0-1453-DF4C-881E-990FE459E22E}" dt="2025-06-19T04:53:43.832" v="376" actId="14100"/>
          <ac:picMkLst>
            <pc:docMk/>
            <pc:sldMk cId="2132240086" sldId="256"/>
            <ac:picMk id="3" creationId="{DD3E45EF-CEBF-CF71-49D9-7252B84A23FC}"/>
          </ac:picMkLst>
        </pc:picChg>
        <pc:picChg chg="del">
          <ac:chgData name="Caiming Xu" userId="e18c41139f0e09dd" providerId="LiveId" clId="{7F6F38B0-1453-DF4C-881E-990FE459E22E}" dt="2025-06-19T04:50:41.852" v="354" actId="478"/>
          <ac:picMkLst>
            <pc:docMk/>
            <pc:sldMk cId="2132240086" sldId="256"/>
            <ac:picMk id="5" creationId="{1538BEA5-9AD2-148F-2B6E-1E2C5C96FE69}"/>
          </ac:picMkLst>
        </pc:picChg>
        <pc:picChg chg="add mod modCrop">
          <ac:chgData name="Caiming Xu" userId="e18c41139f0e09dd" providerId="LiveId" clId="{7F6F38B0-1453-DF4C-881E-990FE459E22E}" dt="2025-06-19T04:56:42.132" v="459" actId="18331"/>
          <ac:picMkLst>
            <pc:docMk/>
            <pc:sldMk cId="2132240086" sldId="256"/>
            <ac:picMk id="10" creationId="{67120CEE-3AAC-C42C-CDC2-9A022829A1FB}"/>
          </ac:picMkLst>
        </pc:picChg>
        <pc:picChg chg="del">
          <ac:chgData name="Caiming Xu" userId="e18c41139f0e09dd" providerId="LiveId" clId="{7F6F38B0-1453-DF4C-881E-990FE459E22E}" dt="2025-06-19T04:54:47.837" v="433" actId="478"/>
          <ac:picMkLst>
            <pc:docMk/>
            <pc:sldMk cId="2132240086" sldId="256"/>
            <ac:picMk id="11" creationId="{288961C9-90DD-70A1-5C23-96DB8B307F23}"/>
          </ac:picMkLst>
        </pc:picChg>
        <pc:cxnChg chg="mod">
          <ac:chgData name="Caiming Xu" userId="e18c41139f0e09dd" providerId="LiveId" clId="{7F6F38B0-1453-DF4C-881E-990FE459E22E}" dt="2025-06-19T04:54:20.101" v="405" actId="1038"/>
          <ac:cxnSpMkLst>
            <pc:docMk/>
            <pc:sldMk cId="2132240086" sldId="256"/>
            <ac:cxnSpMk id="6" creationId="{ED06550C-E6ED-6ED6-6D5D-FDE307420916}"/>
          </ac:cxnSpMkLst>
        </pc:cxnChg>
        <pc:cxnChg chg="mod">
          <ac:chgData name="Caiming Xu" userId="e18c41139f0e09dd" providerId="LiveId" clId="{7F6F38B0-1453-DF4C-881E-990FE459E22E}" dt="2025-06-19T04:54:33.298" v="431" actId="1038"/>
          <ac:cxnSpMkLst>
            <pc:docMk/>
            <pc:sldMk cId="2132240086" sldId="256"/>
            <ac:cxnSpMk id="14" creationId="{4D500BFD-26C1-13C8-28CF-CDCC68C79F24}"/>
          </ac:cxnSpMkLst>
        </pc:cxnChg>
        <pc:cxnChg chg="mod">
          <ac:chgData name="Caiming Xu" userId="e18c41139f0e09dd" providerId="LiveId" clId="{7F6F38B0-1453-DF4C-881E-990FE459E22E}" dt="2025-06-19T04:54:25.570" v="409" actId="1035"/>
          <ac:cxnSpMkLst>
            <pc:docMk/>
            <pc:sldMk cId="2132240086" sldId="256"/>
            <ac:cxnSpMk id="15" creationId="{55C6DBD4-5EDB-8755-7797-229B9045F37F}"/>
          </ac:cxnSpMkLst>
        </pc:cxnChg>
      </pc:sldChg>
      <pc:sldChg chg="addSp delSp modSp mod">
        <pc:chgData name="Caiming Xu" userId="e18c41139f0e09dd" providerId="LiveId" clId="{7F6F38B0-1453-DF4C-881E-990FE459E22E}" dt="2025-06-17T05:44:53.322" v="210" actId="1076"/>
        <pc:sldMkLst>
          <pc:docMk/>
          <pc:sldMk cId="534533243" sldId="265"/>
        </pc:sldMkLst>
        <pc:spChg chg="mod">
          <ac:chgData name="Caiming Xu" userId="e18c41139f0e09dd" providerId="LiveId" clId="{7F6F38B0-1453-DF4C-881E-990FE459E22E}" dt="2025-06-17T05:44:53.322" v="210" actId="1076"/>
          <ac:spMkLst>
            <pc:docMk/>
            <pc:sldMk cId="534533243" sldId="265"/>
            <ac:spMk id="5" creationId="{F45AE735-6C8C-5D76-F5AC-92D01D792999}"/>
          </ac:spMkLst>
        </pc:spChg>
        <pc:spChg chg="mod topLvl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11" creationId="{DA529DE9-46FC-5E15-A108-FD858B84298E}"/>
          </ac:spMkLst>
        </pc:spChg>
        <pc:spChg chg="mod topLvl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29" creationId="{4C3807FC-C178-9670-D692-55E2BA689C21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35" creationId="{F3B1344A-1FE9-B6CD-09EE-0369DA383445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36" creationId="{A5627EAC-658D-3C2E-DFBB-5AE0056DE449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37" creationId="{7C103526-C63B-2A4B-B12B-CDA744D9473B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38" creationId="{82C1F613-5226-3F69-357D-DA5A8431BFE6}"/>
          </ac:spMkLst>
        </pc:spChg>
        <pc:spChg chg="mod">
          <ac:chgData name="Caiming Xu" userId="e18c41139f0e09dd" providerId="LiveId" clId="{7F6F38B0-1453-DF4C-881E-990FE459E22E}" dt="2025-06-17T05:31:11.531" v="149" actId="1076"/>
          <ac:spMkLst>
            <pc:docMk/>
            <pc:sldMk cId="534533243" sldId="265"/>
            <ac:spMk id="48" creationId="{0C9E1EF0-E375-FB6D-A400-BCE9F44D003A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49" creationId="{BB5F1733-FFE5-7EA9-4977-D9C20088C662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52" creationId="{A578538C-6277-21C3-5BA1-F05FC1BAD544}"/>
          </ac:spMkLst>
        </pc:spChg>
        <pc:spChg chg="mod">
          <ac:chgData name="Caiming Xu" userId="e18c41139f0e09dd" providerId="LiveId" clId="{7F6F38B0-1453-DF4C-881E-990FE459E22E}" dt="2025-06-17T05:30:44.106" v="146" actId="1035"/>
          <ac:spMkLst>
            <pc:docMk/>
            <pc:sldMk cId="534533243" sldId="265"/>
            <ac:spMk id="53" creationId="{09B81EDF-957C-9771-95B3-7FABD28853A3}"/>
          </ac:spMkLst>
        </pc:spChg>
        <pc:spChg chg="mod">
          <ac:chgData name="Caiming Xu" userId="e18c41139f0e09dd" providerId="LiveId" clId="{7F6F38B0-1453-DF4C-881E-990FE459E22E}" dt="2025-06-17T05:44:30.617" v="202" actId="165"/>
          <ac:spMkLst>
            <pc:docMk/>
            <pc:sldMk cId="534533243" sldId="265"/>
            <ac:spMk id="70" creationId="{286417CD-2ED5-7E1A-5454-FDF9837F351D}"/>
          </ac:spMkLst>
        </pc:spChg>
        <pc:spChg chg="mod">
          <ac:chgData name="Caiming Xu" userId="e18c41139f0e09dd" providerId="LiveId" clId="{7F6F38B0-1453-DF4C-881E-990FE459E22E}" dt="2025-06-17T05:44:47.703" v="209" actId="1035"/>
          <ac:spMkLst>
            <pc:docMk/>
            <pc:sldMk cId="534533243" sldId="265"/>
            <ac:spMk id="76" creationId="{8215D3BA-A293-F57B-BC35-EB3BCCFEF567}"/>
          </ac:spMkLst>
        </pc:spChg>
        <pc:grpChg chg="mod">
          <ac:chgData name="Caiming Xu" userId="e18c41139f0e09dd" providerId="LiveId" clId="{7F6F38B0-1453-DF4C-881E-990FE459E22E}" dt="2025-06-17T05:44:39.474" v="204" actId="14100"/>
          <ac:grpSpMkLst>
            <pc:docMk/>
            <pc:sldMk cId="534533243" sldId="265"/>
            <ac:grpSpMk id="83" creationId="{5716D78A-C31A-8253-B6B6-D6D7623A1107}"/>
          </ac:grpSpMkLst>
        </pc:grpChg>
        <pc:picChg chg="add mod modCrop">
          <ac:chgData name="Caiming Xu" userId="e18c41139f0e09dd" providerId="LiveId" clId="{7F6F38B0-1453-DF4C-881E-990FE459E22E}" dt="2025-06-17T05:31:07.053" v="148" actId="14100"/>
          <ac:picMkLst>
            <pc:docMk/>
            <pc:sldMk cId="534533243" sldId="265"/>
            <ac:picMk id="3" creationId="{EBDAD813-2F7A-A5FB-8E5E-E97683E5A84D}"/>
          </ac:picMkLst>
        </pc:picChg>
        <pc:picChg chg="add mod modCrop">
          <ac:chgData name="Caiming Xu" userId="e18c41139f0e09dd" providerId="LiveId" clId="{7F6F38B0-1453-DF4C-881E-990FE459E22E}" dt="2025-06-17T05:44:18.989" v="200" actId="1076"/>
          <ac:picMkLst>
            <pc:docMk/>
            <pc:sldMk cId="534533243" sldId="265"/>
            <ac:picMk id="7" creationId="{D9187EA4-08C2-E6B6-7DB5-8E71858514A8}"/>
          </ac:picMkLst>
        </pc:picChg>
        <pc:cxnChg chg="mod">
          <ac:chgData name="Caiming Xu" userId="e18c41139f0e09dd" providerId="LiveId" clId="{7F6F38B0-1453-DF4C-881E-990FE459E22E}" dt="2025-06-17T05:44:47.703" v="209" actId="1035"/>
          <ac:cxnSpMkLst>
            <pc:docMk/>
            <pc:sldMk cId="534533243" sldId="265"/>
            <ac:cxnSpMk id="75" creationId="{A657C358-F13B-A9E1-1F9D-AD1784B67438}"/>
          </ac:cxnSpMkLst>
        </pc:cxnChg>
      </pc:sldChg>
      <pc:sldChg chg="addSp delSp modSp mod">
        <pc:chgData name="Caiming Xu" userId="e18c41139f0e09dd" providerId="LiveId" clId="{7F6F38B0-1453-DF4C-881E-990FE459E22E}" dt="2025-06-17T06:07:55.481" v="353" actId="1035"/>
        <pc:sldMkLst>
          <pc:docMk/>
          <pc:sldMk cId="767339383" sldId="267"/>
        </pc:sldMkLst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4" creationId="{6BF88942-B281-B21E-79E5-51268C4FB640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5" creationId="{D6A56B63-E899-DC59-FCBF-73DEC173191D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6" creationId="{C961B193-A521-094F-757A-603415E91AFF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9" creationId="{AD1D2EFF-9147-4D9E-5BB8-2EEE943211D8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11" creationId="{DA2E5F59-DFDF-FB3A-5FA1-AB94AD7F3495}"/>
          </ac:spMkLst>
        </pc:spChg>
        <pc:spChg chg="mod topLvl">
          <ac:chgData name="Caiming Xu" userId="e18c41139f0e09dd" providerId="LiveId" clId="{7F6F38B0-1453-DF4C-881E-990FE459E22E}" dt="2025-06-02T04:12:37.395" v="60" actId="164"/>
          <ac:spMkLst>
            <pc:docMk/>
            <pc:sldMk cId="767339383" sldId="267"/>
            <ac:spMk id="13" creationId="{E090BC8D-83ED-99CD-8004-77CEEFB7756E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26" creationId="{9540F9B1-2ADC-378A-0C8A-B781ABB53611}"/>
          </ac:spMkLst>
        </pc:spChg>
        <pc:spChg chg="mod topLvl">
          <ac:chgData name="Caiming Xu" userId="e18c41139f0e09dd" providerId="LiveId" clId="{7F6F38B0-1453-DF4C-881E-990FE459E22E}" dt="2025-06-17T06:07:26.900" v="279" actId="165"/>
          <ac:spMkLst>
            <pc:docMk/>
            <pc:sldMk cId="767339383" sldId="267"/>
            <ac:spMk id="27" creationId="{FDFEB9F1-1E4D-BF8B-CDFD-30E354D595D4}"/>
          </ac:spMkLst>
        </pc:spChg>
        <pc:spChg chg="mod topLvl">
          <ac:chgData name="Caiming Xu" userId="e18c41139f0e09dd" providerId="LiveId" clId="{7F6F38B0-1453-DF4C-881E-990FE459E22E}" dt="2025-06-17T06:07:47.997" v="329" actId="1036"/>
          <ac:spMkLst>
            <pc:docMk/>
            <pc:sldMk cId="767339383" sldId="267"/>
            <ac:spMk id="28" creationId="{E6F49C4E-A77C-FC2D-E311-1D3CE110DD85}"/>
          </ac:spMkLst>
        </pc:spChg>
        <pc:spChg chg="mod topLvl">
          <ac:chgData name="Caiming Xu" userId="e18c41139f0e09dd" providerId="LiveId" clId="{7F6F38B0-1453-DF4C-881E-990FE459E22E}" dt="2025-06-17T06:07:41.156" v="309" actId="1036"/>
          <ac:spMkLst>
            <pc:docMk/>
            <pc:sldMk cId="767339383" sldId="267"/>
            <ac:spMk id="33" creationId="{0C002FF2-6250-F5BC-8A39-A370F7A70F00}"/>
          </ac:spMkLst>
        </pc:spChg>
        <pc:spChg chg="mod topLvl">
          <ac:chgData name="Caiming Xu" userId="e18c41139f0e09dd" providerId="LiveId" clId="{7F6F38B0-1453-DF4C-881E-990FE459E22E}" dt="2025-06-17T06:07:35.281" v="298" actId="1036"/>
          <ac:spMkLst>
            <pc:docMk/>
            <pc:sldMk cId="767339383" sldId="267"/>
            <ac:spMk id="36" creationId="{67A46F03-D481-4731-D190-7815E8849A7C}"/>
          </ac:spMkLst>
        </pc:spChg>
        <pc:spChg chg="mod topLvl">
          <ac:chgData name="Caiming Xu" userId="e18c41139f0e09dd" providerId="LiveId" clId="{7F6F38B0-1453-DF4C-881E-990FE459E22E}" dt="2025-06-17T06:07:55.481" v="353" actId="1035"/>
          <ac:spMkLst>
            <pc:docMk/>
            <pc:sldMk cId="767339383" sldId="267"/>
            <ac:spMk id="38" creationId="{7FEF0EAC-EBED-E41E-C8CF-DBD0ACD0407A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53" creationId="{EBCA6019-6B68-3A70-45E5-EA34AFF2879D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54" creationId="{C6116357-9AF9-DC12-50F0-16F30DA5B012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55" creationId="{F350681E-43F6-96F4-9C13-3F50787CBC81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56" creationId="{D50D97AD-0D4F-E155-C212-7B66932CD71B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57" creationId="{DE1A67EE-F65E-A565-35F5-405308F6E8BF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69" creationId="{F4BF06B4-19FA-9E83-12D0-4B1A2ABFEC5D}"/>
          </ac:spMkLst>
        </pc:spChg>
        <pc:spChg chg="mod topLvl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72" creationId="{A794FA63-17F3-0B46-058B-A26872C05A0F}"/>
          </ac:spMkLst>
        </pc:spChg>
        <pc:spChg chg="mod">
          <ac:chgData name="Caiming Xu" userId="e18c41139f0e09dd" providerId="LiveId" clId="{7F6F38B0-1453-DF4C-881E-990FE459E22E}" dt="2025-06-02T04:13:37.756" v="81" actId="164"/>
          <ac:spMkLst>
            <pc:docMk/>
            <pc:sldMk cId="767339383" sldId="267"/>
            <ac:spMk id="73" creationId="{B998FEE8-38B2-F58B-5BC6-50FBC47128AB}"/>
          </ac:spMkLst>
        </pc:spChg>
        <pc:spChg chg="mod">
          <ac:chgData name="Caiming Xu" userId="e18c41139f0e09dd" providerId="LiveId" clId="{7F6F38B0-1453-DF4C-881E-990FE459E22E}" dt="2025-06-02T04:13:48.212" v="84"/>
          <ac:spMkLst>
            <pc:docMk/>
            <pc:sldMk cId="767339383" sldId="267"/>
            <ac:spMk id="85" creationId="{382854CA-06F9-892A-7B80-4B63B31A99E4}"/>
          </ac:spMkLst>
        </pc:spChg>
        <pc:spChg chg="mod">
          <ac:chgData name="Caiming Xu" userId="e18c41139f0e09dd" providerId="LiveId" clId="{7F6F38B0-1453-DF4C-881E-990FE459E22E}" dt="2025-06-02T04:13:48.212" v="84"/>
          <ac:spMkLst>
            <pc:docMk/>
            <pc:sldMk cId="767339383" sldId="267"/>
            <ac:spMk id="86" creationId="{52E55EE1-F7F8-EBB2-5227-76A3BCDA4B92}"/>
          </ac:spMkLst>
        </pc:spChg>
        <pc:grpChg chg="add mod">
          <ac:chgData name="Caiming Xu" userId="e18c41139f0e09dd" providerId="LiveId" clId="{7F6F38B0-1453-DF4C-881E-990FE459E22E}" dt="2025-06-02T04:13:40.529" v="82" actId="1076"/>
          <ac:grpSpMkLst>
            <pc:docMk/>
            <pc:sldMk cId="767339383" sldId="267"/>
            <ac:grpSpMk id="83" creationId="{AB0ADEFA-C2FB-4A84-D777-7A6E63020C02}"/>
          </ac:grpSpMkLst>
        </pc:grpChg>
        <pc:grpChg chg="add mod">
          <ac:chgData name="Caiming Xu" userId="e18c41139f0e09dd" providerId="LiveId" clId="{7F6F38B0-1453-DF4C-881E-990FE459E22E}" dt="2025-06-02T04:13:48.212" v="84"/>
          <ac:grpSpMkLst>
            <pc:docMk/>
            <pc:sldMk cId="767339383" sldId="267"/>
            <ac:grpSpMk id="84" creationId="{0F6B74B6-1C0C-C7AF-35E9-D79D922BE44E}"/>
          </ac:grpSpMkLst>
        </pc:grpChg>
        <pc:picChg chg="add mod modCrop">
          <ac:chgData name="Caiming Xu" userId="e18c41139f0e09dd" providerId="LiveId" clId="{7F6F38B0-1453-DF4C-881E-990FE459E22E}" dt="2025-06-17T05:57:21.239" v="235" actId="1036"/>
          <ac:picMkLst>
            <pc:docMk/>
            <pc:sldMk cId="767339383" sldId="267"/>
            <ac:picMk id="7" creationId="{9B2D4C15-E430-2CBE-BFE4-BDB7744513E4}"/>
          </ac:picMkLst>
        </pc:picChg>
        <pc:picChg chg="add mod modCrop">
          <ac:chgData name="Caiming Xu" userId="e18c41139f0e09dd" providerId="LiveId" clId="{7F6F38B0-1453-DF4C-881E-990FE459E22E}" dt="2025-06-17T06:07:20.421" v="278" actId="1076"/>
          <ac:picMkLst>
            <pc:docMk/>
            <pc:sldMk cId="767339383" sldId="267"/>
            <ac:picMk id="14" creationId="{A37D20D7-C500-CF23-F8E3-C4B7B6242DB8}"/>
          </ac:picMkLst>
        </pc:picChg>
        <pc:cxnChg chg="mod">
          <ac:chgData name="Caiming Xu" userId="e18c41139f0e09dd" providerId="LiveId" clId="{7F6F38B0-1453-DF4C-881E-990FE459E22E}" dt="2025-06-02T04:12:29.621" v="59" actId="1037"/>
          <ac:cxnSpMkLst>
            <pc:docMk/>
            <pc:sldMk cId="767339383" sldId="267"/>
            <ac:cxnSpMk id="18" creationId="{7807E239-0FA9-9D87-6553-0FA88F284AC7}"/>
          </ac:cxnSpMkLst>
        </pc:cxnChg>
        <pc:cxnChg chg="mod">
          <ac:chgData name="Caiming Xu" userId="e18c41139f0e09dd" providerId="LiveId" clId="{7F6F38B0-1453-DF4C-881E-990FE459E22E}" dt="2025-06-17T06:07:44.778" v="324" actId="1035"/>
          <ac:cxnSpMkLst>
            <pc:docMk/>
            <pc:sldMk cId="767339383" sldId="267"/>
            <ac:cxnSpMk id="29" creationId="{7404A6FD-7FF2-49A8-C1F6-E3DDDA6F6EA3}"/>
          </ac:cxnSpMkLst>
        </pc:cxnChg>
        <pc:cxnChg chg="mod">
          <ac:chgData name="Caiming Xu" userId="e18c41139f0e09dd" providerId="LiveId" clId="{7F6F38B0-1453-DF4C-881E-990FE459E22E}" dt="2025-06-17T06:07:41.156" v="309" actId="1036"/>
          <ac:cxnSpMkLst>
            <pc:docMk/>
            <pc:sldMk cId="767339383" sldId="267"/>
            <ac:cxnSpMk id="30" creationId="{74354650-D30D-2488-FD45-7C7EC5BC6054}"/>
          </ac:cxnSpMkLst>
        </pc:cxnChg>
        <pc:cxnChg chg="mod">
          <ac:chgData name="Caiming Xu" userId="e18c41139f0e09dd" providerId="LiveId" clId="{7F6F38B0-1453-DF4C-881E-990FE459E22E}" dt="2025-06-17T06:07:35.281" v="298" actId="1036"/>
          <ac:cxnSpMkLst>
            <pc:docMk/>
            <pc:sldMk cId="767339383" sldId="267"/>
            <ac:cxnSpMk id="35" creationId="{55BBF17F-DA9C-4DB9-19C6-22071402CAAE}"/>
          </ac:cxnSpMkLst>
        </pc:cxnChg>
        <pc:cxnChg chg="mod">
          <ac:chgData name="Caiming Xu" userId="e18c41139f0e09dd" providerId="LiveId" clId="{7F6F38B0-1453-DF4C-881E-990FE459E22E}" dt="2025-06-17T06:07:52.856" v="344" actId="1036"/>
          <ac:cxnSpMkLst>
            <pc:docMk/>
            <pc:sldMk cId="767339383" sldId="267"/>
            <ac:cxnSpMk id="37" creationId="{CAE4B61F-A637-CBD3-32A6-7495140AFC5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C68232-83C2-6A90-F28D-263F3F1170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EDCEE58-776E-6EA7-8D5B-F4C10349D1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B7454F-DAB8-F5F1-38B8-575B478EC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FF5B87-4602-DCAF-91B1-DBBC151B8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9AD5D4-1225-4C95-F11B-7EA0696AB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7523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2F37FC-1B05-0A3B-4A5B-556EACBDF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5E39A7-A978-9E9B-86ED-DF170F7CCA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1812C4-036C-5B55-6CA6-8B91F0303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C7DED9-BA19-CB58-E90A-D0F3C9618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A1F3C9-13E4-86C9-F9CE-BFFBD1EDD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7330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EA3CB9F-26ED-185D-9FC4-47F800A89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97D726-26D1-E4E3-A96C-96D998A766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6258D3-D5E3-BFAC-29D1-102288DA3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A3AF99-27A1-F44D-BFC8-2C58EA41B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171012-2EB7-0FA9-B1C4-609CF4542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04250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02A197-8AEA-DBF8-B8D3-C58F84657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FD142-9E0A-64E7-743B-68BFF8F81B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AD1A46-034D-3276-E162-0A5A2EACB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E8C3FB-4DC8-DFF6-D3D6-5BE412677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52C391-E100-728F-D914-02D5B648D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0993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073D65-E0AB-0644-8782-86A5727BF8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9044EF-802D-6486-D002-3A9829ACBC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30DFC7-3D4B-603B-CF05-6700E6ADF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386B0C-A7A2-89A0-50A8-D86516C41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8F23E9-0F34-DCAF-276C-EF1D8DDD0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6113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A1A728-C6FB-AE88-7CBC-BEBC61C3F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0FEF51-E96A-62E7-06D1-A73A3DBE4E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561850B-D6C2-26E7-E45A-B817651BFB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CCD202-3EDB-91AA-311E-E23E1F9F3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CA7F3A-BB39-58A1-A8EC-F85B9025F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A82F92-BA76-CCDF-EF94-164F62063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0545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4EFAD-316E-42DB-4E91-618124B80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87FE9A-FBDF-2194-8C8F-8CC63A59F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92CEF31-9431-36DE-E4D4-BE9AE05B05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3C7E0E3-E64D-B9AE-3BE5-F325744320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B7FAC2E-B68C-0639-CA52-36AC1B2702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227F203-EB19-3C11-FE64-407AAD4D3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3962174-442B-7CC3-3C91-68EEE7AB7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0EBE96C-9C08-A167-CB99-BF9D352CC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97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D9E195-E782-F8ED-5073-A45C5D74B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CBEBB03-ADAC-2D08-065B-342FD28EA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564C72B-CC67-8753-0662-56B49684A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F445EEE-C1B8-7BAD-A705-654D0A254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8377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D47C9AE-DD30-758C-E12F-A3BA25044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4150EEC-7C56-1888-9C3F-28E6B4AA3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EC5FE3B-73DA-E670-35E9-76FD62647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681365-15FE-63B3-A504-1D70D2D6B7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8D73BB2-EAE0-D484-6340-902FB2104A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5974D1F-5FA3-7016-9719-8CD6546AA3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B66D8C-45F9-5410-86C9-0819B3DEE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1DE7AD-0F77-412C-7806-317055220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4F444F-F95D-8041-CCD1-6D7BD3F13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2688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30264F-8457-7E4B-A11D-C0F70D4CB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02E023F-B305-716A-9B04-9BC33248FA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4CD1FBD-0CA0-3ACC-805A-A34717CE3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A209C1-2C8E-6049-1687-339DE7305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362495-BE3C-D628-59CB-DFBA0042D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4149B1-5519-45AC-5970-9B05632C0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6841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6E84DAD-8D81-2C83-F251-CF423C9051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90C10C-DCB2-9DEA-9BE6-F895FCB5D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CBAECE-FFA1-1F0F-50C8-6C4B79EF9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7BA563-42B2-8A45-A8BC-CC5674E84F16}" type="datetimeFigureOut">
              <a:rPr kumimoji="1" lang="zh-CN" altLang="en-US" smtClean="0"/>
              <a:t>2025/6/18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8781EB-D72A-02D6-E426-B70281D93E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B176A1-C306-6C8A-82A0-5D5904E0A7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19091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 descr="图片包含 游戏机, 空气, 飞行, 男人&#10;&#10;AI 生成的内容可能不正确。">
            <a:extLst>
              <a:ext uri="{FF2B5EF4-FFF2-40B4-BE49-F238E27FC236}">
                <a16:creationId xmlns:a16="http://schemas.microsoft.com/office/drawing/2014/main" id="{67120CEE-3AAC-C42C-CDC2-9A022829A1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561165" y="2823734"/>
            <a:ext cx="2934140" cy="1212946"/>
          </a:xfrm>
          <a:prstGeom prst="rect">
            <a:avLst/>
          </a:prstGeom>
        </p:spPr>
      </p:pic>
      <p:pic>
        <p:nvPicPr>
          <p:cNvPr id="3" name="图片 2" descr="图片包含 桌子, 标志&#10;&#10;AI 生成的内容可能不正确。">
            <a:extLst>
              <a:ext uri="{FF2B5EF4-FFF2-40B4-BE49-F238E27FC236}">
                <a16:creationId xmlns:a16="http://schemas.microsoft.com/office/drawing/2014/main" id="{DD3E45EF-CEBF-CF71-49D9-7252B84A23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159496" y="2806990"/>
            <a:ext cx="2915266" cy="1119963"/>
          </a:xfrm>
          <a:prstGeom prst="rect">
            <a:avLst/>
          </a:prstGeom>
        </p:spPr>
      </p:pic>
      <p:grpSp>
        <p:nvGrpSpPr>
          <p:cNvPr id="31" name="组合 30">
            <a:extLst>
              <a:ext uri="{FF2B5EF4-FFF2-40B4-BE49-F238E27FC236}">
                <a16:creationId xmlns:a16="http://schemas.microsoft.com/office/drawing/2014/main" id="{BF27719F-DEB8-BDB0-FFF0-186B7F2DA28A}"/>
              </a:ext>
            </a:extLst>
          </p:cNvPr>
          <p:cNvGrpSpPr/>
          <p:nvPr/>
        </p:nvGrpSpPr>
        <p:grpSpPr>
          <a:xfrm>
            <a:off x="9019538" y="4998413"/>
            <a:ext cx="2106667" cy="1094920"/>
            <a:chOff x="9552163" y="5078195"/>
            <a:chExt cx="2106667" cy="1094920"/>
          </a:xfrm>
        </p:grpSpPr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6B3D5AA-8099-3373-F009-A7C9605B0510}"/>
                </a:ext>
              </a:extLst>
            </p:cNvPr>
            <p:cNvSpPr txBox="1"/>
            <p:nvPr/>
          </p:nvSpPr>
          <p:spPr>
            <a:xfrm>
              <a:off x="9552163" y="5078195"/>
              <a:ext cx="8114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97EAAE0-87F1-470A-B80F-BBE947E1DF72}"/>
                </a:ext>
              </a:extLst>
            </p:cNvPr>
            <p:cNvSpPr txBox="1"/>
            <p:nvPr/>
          </p:nvSpPr>
          <p:spPr>
            <a:xfrm>
              <a:off x="9552163" y="5465229"/>
              <a:ext cx="2106667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E circ-EGFR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0D3724C5-278F-0B46-92EF-B4727542F29F}"/>
              </a:ext>
            </a:extLst>
          </p:cNvPr>
          <p:cNvGrpSpPr>
            <a:grpSpLocks noChangeAspect="1"/>
          </p:cNvGrpSpPr>
          <p:nvPr/>
        </p:nvGrpSpPr>
        <p:grpSpPr>
          <a:xfrm>
            <a:off x="6608766" y="1879084"/>
            <a:ext cx="4552096" cy="1665893"/>
            <a:chOff x="7936127" y="2723444"/>
            <a:chExt cx="2505963" cy="917087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5A0704D2-6906-49DE-364D-7BDBD420E93B}"/>
                </a:ext>
              </a:extLst>
            </p:cNvPr>
            <p:cNvSpPr txBox="1"/>
            <p:nvPr/>
          </p:nvSpPr>
          <p:spPr>
            <a:xfrm>
              <a:off x="7936127" y="3437739"/>
              <a:ext cx="440520" cy="2027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463A877-3C6F-4374-3D8E-C25A43384A3F}"/>
                </a:ext>
              </a:extLst>
            </p:cNvPr>
            <p:cNvSpPr txBox="1"/>
            <p:nvPr/>
          </p:nvSpPr>
          <p:spPr>
            <a:xfrm>
              <a:off x="9971560" y="3413915"/>
              <a:ext cx="470530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BF7BEE6E-4140-4678-2564-1C01540F83B6}"/>
                </a:ext>
              </a:extLst>
            </p:cNvPr>
            <p:cNvGrpSpPr/>
            <p:nvPr/>
          </p:nvGrpSpPr>
          <p:grpSpPr>
            <a:xfrm>
              <a:off x="8714215" y="2723444"/>
              <a:ext cx="1223757" cy="504942"/>
              <a:chOff x="3682254" y="2597771"/>
              <a:chExt cx="1223757" cy="504942"/>
            </a:xfrm>
          </p:grpSpPr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6DA03D16-0D26-1B0F-F235-EEA6CFC35E33}"/>
                  </a:ext>
                </a:extLst>
              </p:cNvPr>
              <p:cNvGrpSpPr/>
              <p:nvPr/>
            </p:nvGrpSpPr>
            <p:grpSpPr>
              <a:xfrm>
                <a:off x="3757788" y="2882446"/>
                <a:ext cx="1056184" cy="220267"/>
                <a:chOff x="3919713" y="3233578"/>
                <a:chExt cx="1056184" cy="220267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A901A56F-1A4D-71A7-DBBE-90C754ACDE19}"/>
                    </a:ext>
                  </a:extLst>
                </p:cNvPr>
                <p:cNvSpPr txBox="1"/>
                <p:nvPr/>
              </p:nvSpPr>
              <p:spPr>
                <a:xfrm>
                  <a:off x="3919713" y="3233578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6021E058-0C63-8E9B-4CE7-1223CD3EBC88}"/>
                    </a:ext>
                  </a:extLst>
                </p:cNvPr>
                <p:cNvSpPr txBox="1"/>
                <p:nvPr/>
              </p:nvSpPr>
              <p:spPr>
                <a:xfrm>
                  <a:off x="4226614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4219856A-D131-FDC9-371B-DEEAEDC45E35}"/>
                    </a:ext>
                  </a:extLst>
                </p:cNvPr>
                <p:cNvSpPr txBox="1"/>
                <p:nvPr/>
              </p:nvSpPr>
              <p:spPr>
                <a:xfrm>
                  <a:off x="4507484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C6209E8C-C94E-3A84-6DB7-9C892420CCD7}"/>
                    </a:ext>
                  </a:extLst>
                </p:cNvPr>
                <p:cNvSpPr txBox="1"/>
                <p:nvPr/>
              </p:nvSpPr>
              <p:spPr>
                <a:xfrm>
                  <a:off x="4795697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61" name="直线连接符 60">
                <a:extLst>
                  <a:ext uri="{FF2B5EF4-FFF2-40B4-BE49-F238E27FC236}">
                    <a16:creationId xmlns:a16="http://schemas.microsoft.com/office/drawing/2014/main" id="{6CCBE062-240B-769F-8E5C-6870AC241653}"/>
                  </a:ext>
                </a:extLst>
              </p:cNvPr>
              <p:cNvCxnSpPr/>
              <p:nvPr/>
            </p:nvCxnSpPr>
            <p:spPr>
              <a:xfrm>
                <a:off x="3727315" y="2848836"/>
                <a:ext cx="5039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线连接符 61">
                <a:extLst>
                  <a:ext uri="{FF2B5EF4-FFF2-40B4-BE49-F238E27FC236}">
                    <a16:creationId xmlns:a16="http://schemas.microsoft.com/office/drawing/2014/main" id="{36961B3D-D10B-54A0-BFA4-223428073BFE}"/>
                  </a:ext>
                </a:extLst>
              </p:cNvPr>
              <p:cNvCxnSpPr/>
              <p:nvPr/>
            </p:nvCxnSpPr>
            <p:spPr>
              <a:xfrm>
                <a:off x="4335037" y="2848059"/>
                <a:ext cx="50399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3D17E418-57EE-6637-8653-8490F0D9174A}"/>
                  </a:ext>
                </a:extLst>
              </p:cNvPr>
              <p:cNvSpPr txBox="1"/>
              <p:nvPr/>
            </p:nvSpPr>
            <p:spPr>
              <a:xfrm>
                <a:off x="3682254" y="2597771"/>
                <a:ext cx="572897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CO2</a:t>
                </a:r>
                <a:endParaRPr kumimoji="1" lang="zh-CN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81A58397-1298-2371-D089-0F0F227AB878}"/>
                  </a:ext>
                </a:extLst>
              </p:cNvPr>
              <p:cNvSpPr txBox="1"/>
              <p:nvPr/>
            </p:nvSpPr>
            <p:spPr>
              <a:xfrm>
                <a:off x="4277519" y="2597771"/>
                <a:ext cx="628492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NU-C1</a:t>
                </a:r>
                <a:endParaRPr kumimoji="1" lang="zh-CN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461DFD30-ED25-8967-33C7-E34ACFBF846E}"/>
              </a:ext>
            </a:extLst>
          </p:cNvPr>
          <p:cNvSpPr txBox="1"/>
          <p:nvPr/>
        </p:nvSpPr>
        <p:spPr>
          <a:xfrm>
            <a:off x="627161" y="3209317"/>
            <a:ext cx="943325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AS1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BEA0B48-CDC9-2EFD-07B1-39E0462503D0}"/>
              </a:ext>
            </a:extLst>
          </p:cNvPr>
          <p:cNvSpPr txBox="1"/>
          <p:nvPr/>
        </p:nvSpPr>
        <p:spPr>
          <a:xfrm>
            <a:off x="1629257" y="3719871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4D500BFD-26C1-13C8-28CF-CDCC68C79F24}"/>
              </a:ext>
            </a:extLst>
          </p:cNvPr>
          <p:cNvCxnSpPr>
            <a:cxnSpLocks/>
          </p:cNvCxnSpPr>
          <p:nvPr/>
        </p:nvCxnSpPr>
        <p:spPr>
          <a:xfrm>
            <a:off x="2052544" y="390739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55C6DBD4-5EDB-8755-7797-229B9045F37F}"/>
              </a:ext>
            </a:extLst>
          </p:cNvPr>
          <p:cNvCxnSpPr>
            <a:cxnSpLocks/>
          </p:cNvCxnSpPr>
          <p:nvPr/>
        </p:nvCxnSpPr>
        <p:spPr>
          <a:xfrm>
            <a:off x="2046901" y="3472404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980BAC4B-4EA8-CA5D-FE28-5D48DBE73DAB}"/>
              </a:ext>
            </a:extLst>
          </p:cNvPr>
          <p:cNvSpPr txBox="1"/>
          <p:nvPr/>
        </p:nvSpPr>
        <p:spPr>
          <a:xfrm>
            <a:off x="1629257" y="3280728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2C7E0BE-0499-B8B2-C350-7C1538806105}"/>
              </a:ext>
            </a:extLst>
          </p:cNvPr>
          <p:cNvSpPr txBox="1"/>
          <p:nvPr/>
        </p:nvSpPr>
        <p:spPr>
          <a:xfrm>
            <a:off x="5099496" y="3209317"/>
            <a:ext cx="927665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56B14B4D-9EA8-1801-9F04-73035682F55C}"/>
              </a:ext>
            </a:extLst>
          </p:cNvPr>
          <p:cNvGrpSpPr/>
          <p:nvPr/>
        </p:nvGrpSpPr>
        <p:grpSpPr>
          <a:xfrm>
            <a:off x="2743200" y="2389478"/>
            <a:ext cx="2175667" cy="434256"/>
            <a:chOff x="3965831" y="3305229"/>
            <a:chExt cx="1046928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638EF77-7055-71DF-F03F-0C1F4E3F84A4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555B4E8-5C4D-739A-8B43-4DFBCD3985B4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F9B9C9F-4A35-4592-B459-3B0066983B6B}"/>
                </a:ext>
              </a:extLst>
            </p:cNvPr>
            <p:cNvSpPr txBox="1"/>
            <p:nvPr/>
          </p:nvSpPr>
          <p:spPr>
            <a:xfrm>
              <a:off x="4553599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C4F48F5-D522-D931-BB49-81052E46CD42}"/>
                </a:ext>
              </a:extLst>
            </p:cNvPr>
            <p:cNvSpPr txBox="1"/>
            <p:nvPr/>
          </p:nvSpPr>
          <p:spPr>
            <a:xfrm>
              <a:off x="4841804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2" name="直线连接符 41">
            <a:extLst>
              <a:ext uri="{FF2B5EF4-FFF2-40B4-BE49-F238E27FC236}">
                <a16:creationId xmlns:a16="http://schemas.microsoft.com/office/drawing/2014/main" id="{1990E8B2-32C0-6208-DB31-AD2329140580}"/>
              </a:ext>
            </a:extLst>
          </p:cNvPr>
          <p:cNvCxnSpPr>
            <a:cxnSpLocks/>
          </p:cNvCxnSpPr>
          <p:nvPr/>
        </p:nvCxnSpPr>
        <p:spPr>
          <a:xfrm>
            <a:off x="2701732" y="2333734"/>
            <a:ext cx="104738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43">
            <a:extLst>
              <a:ext uri="{FF2B5EF4-FFF2-40B4-BE49-F238E27FC236}">
                <a16:creationId xmlns:a16="http://schemas.microsoft.com/office/drawing/2014/main" id="{BFF3987E-8954-8EE1-C1E8-4850EFE45B49}"/>
              </a:ext>
            </a:extLst>
          </p:cNvPr>
          <p:cNvCxnSpPr>
            <a:cxnSpLocks/>
          </p:cNvCxnSpPr>
          <p:nvPr/>
        </p:nvCxnSpPr>
        <p:spPr>
          <a:xfrm>
            <a:off x="3964666" y="2333734"/>
            <a:ext cx="104738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EB9EC63A-2F6F-007D-0679-39E0F6327DEA}"/>
              </a:ext>
            </a:extLst>
          </p:cNvPr>
          <p:cNvSpPr txBox="1"/>
          <p:nvPr/>
        </p:nvSpPr>
        <p:spPr>
          <a:xfrm>
            <a:off x="2716109" y="1879083"/>
            <a:ext cx="1040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2D2B102-90FB-E715-4148-8E93B0BA66AA}"/>
              </a:ext>
            </a:extLst>
          </p:cNvPr>
          <p:cNvSpPr txBox="1"/>
          <p:nvPr/>
        </p:nvSpPr>
        <p:spPr>
          <a:xfrm>
            <a:off x="3933103" y="1879083"/>
            <a:ext cx="11416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ED06550C-E6ED-6ED6-6D5D-FDE307420916}"/>
              </a:ext>
            </a:extLst>
          </p:cNvPr>
          <p:cNvCxnSpPr>
            <a:cxnSpLocks/>
          </p:cNvCxnSpPr>
          <p:nvPr/>
        </p:nvCxnSpPr>
        <p:spPr>
          <a:xfrm>
            <a:off x="2046901" y="313916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83459769-DAEA-DFB0-7F30-5A84222B8032}"/>
              </a:ext>
            </a:extLst>
          </p:cNvPr>
          <p:cNvSpPr txBox="1"/>
          <p:nvPr/>
        </p:nvSpPr>
        <p:spPr>
          <a:xfrm>
            <a:off x="1629257" y="2949096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22400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863477-913A-966B-2C6A-0C7E61EC12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D9187EA4-08C2-E6B6-7DB5-8E71858514A8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526427" y="3233255"/>
            <a:ext cx="2793572" cy="1164841"/>
          </a:xfrm>
          <a:prstGeom prst="rect">
            <a:avLst/>
          </a:prstGeom>
        </p:spPr>
      </p:pic>
      <p:pic>
        <p:nvPicPr>
          <p:cNvPr id="3" name="图片 2" descr="图片包含 游戏机&#10;&#10;AI 生成的内容可能不正确。">
            <a:extLst>
              <a:ext uri="{FF2B5EF4-FFF2-40B4-BE49-F238E27FC236}">
                <a16:creationId xmlns:a16="http://schemas.microsoft.com/office/drawing/2014/main" id="{EBDAD813-2F7A-A5FB-8E5E-E97683E5A84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936037" y="3066986"/>
            <a:ext cx="3109561" cy="1236618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0C9E1EF0-E375-FB6D-A400-BCE9F44D003A}"/>
              </a:ext>
            </a:extLst>
          </p:cNvPr>
          <p:cNvSpPr txBox="1"/>
          <p:nvPr/>
        </p:nvSpPr>
        <p:spPr>
          <a:xfrm>
            <a:off x="7154387" y="3517395"/>
            <a:ext cx="9877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9B81EDF-957C-9771-95B3-7FABD28853A3}"/>
              </a:ext>
            </a:extLst>
          </p:cNvPr>
          <p:cNvSpPr txBox="1"/>
          <p:nvPr/>
        </p:nvSpPr>
        <p:spPr>
          <a:xfrm>
            <a:off x="10771299" y="3478315"/>
            <a:ext cx="8547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432DC550-727B-D03D-09DB-71E54CD08D8D}"/>
              </a:ext>
            </a:extLst>
          </p:cNvPr>
          <p:cNvGrpSpPr/>
          <p:nvPr/>
        </p:nvGrpSpPr>
        <p:grpSpPr>
          <a:xfrm>
            <a:off x="8378272" y="2732046"/>
            <a:ext cx="2175667" cy="434256"/>
            <a:chOff x="3965831" y="3305229"/>
            <a:chExt cx="1046928" cy="226766"/>
          </a:xfrm>
        </p:grpSpPr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FF6690C2-0CDE-8E84-9FC2-000963A2201D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6540464B-C34E-50B9-A2B0-9DDBD63A6515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F6F6A038-7663-5653-C2D0-738B0175566D}"/>
                </a:ext>
              </a:extLst>
            </p:cNvPr>
            <p:cNvSpPr txBox="1"/>
            <p:nvPr/>
          </p:nvSpPr>
          <p:spPr>
            <a:xfrm>
              <a:off x="4553599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5E20ABF2-4401-A110-6F7E-C23DB548D065}"/>
                </a:ext>
              </a:extLst>
            </p:cNvPr>
            <p:cNvSpPr txBox="1"/>
            <p:nvPr/>
          </p:nvSpPr>
          <p:spPr>
            <a:xfrm>
              <a:off x="4841804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5" name="直线连接符 54">
            <a:extLst>
              <a:ext uri="{FF2B5EF4-FFF2-40B4-BE49-F238E27FC236}">
                <a16:creationId xmlns:a16="http://schemas.microsoft.com/office/drawing/2014/main" id="{6E0EFB99-40B3-7830-FAD6-29C1CDB913C0}"/>
              </a:ext>
            </a:extLst>
          </p:cNvPr>
          <p:cNvCxnSpPr>
            <a:cxnSpLocks/>
          </p:cNvCxnSpPr>
          <p:nvPr/>
        </p:nvCxnSpPr>
        <p:spPr>
          <a:xfrm>
            <a:off x="8336805" y="2676302"/>
            <a:ext cx="104738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线连接符 55">
            <a:extLst>
              <a:ext uri="{FF2B5EF4-FFF2-40B4-BE49-F238E27FC236}">
                <a16:creationId xmlns:a16="http://schemas.microsoft.com/office/drawing/2014/main" id="{9EADC061-ED1E-AC01-0A2B-58CF58525EE3}"/>
              </a:ext>
            </a:extLst>
          </p:cNvPr>
          <p:cNvCxnSpPr>
            <a:cxnSpLocks/>
          </p:cNvCxnSpPr>
          <p:nvPr/>
        </p:nvCxnSpPr>
        <p:spPr>
          <a:xfrm>
            <a:off x="9599738" y="2676302"/>
            <a:ext cx="104738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4EC8DC8D-819F-4B2F-3AB7-92AEDD7EB2F4}"/>
              </a:ext>
            </a:extLst>
          </p:cNvPr>
          <p:cNvSpPr txBox="1"/>
          <p:nvPr/>
        </p:nvSpPr>
        <p:spPr>
          <a:xfrm>
            <a:off x="8351181" y="2221651"/>
            <a:ext cx="1040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891BECD7-8FA4-172B-FE2A-A8FEC6CBFC72}"/>
              </a:ext>
            </a:extLst>
          </p:cNvPr>
          <p:cNvSpPr txBox="1"/>
          <p:nvPr/>
        </p:nvSpPr>
        <p:spPr>
          <a:xfrm>
            <a:off x="9568175" y="2221651"/>
            <a:ext cx="1141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45AE735-6C8C-5D76-F5AC-92D01D792999}"/>
              </a:ext>
            </a:extLst>
          </p:cNvPr>
          <p:cNvSpPr txBox="1"/>
          <p:nvPr/>
        </p:nvSpPr>
        <p:spPr>
          <a:xfrm>
            <a:off x="1008814" y="3523199"/>
            <a:ext cx="9877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A529DE9-46FC-5E15-A108-FD858B84298E}"/>
              </a:ext>
            </a:extLst>
          </p:cNvPr>
          <p:cNvSpPr txBox="1"/>
          <p:nvPr/>
        </p:nvSpPr>
        <p:spPr>
          <a:xfrm>
            <a:off x="5360355" y="3523199"/>
            <a:ext cx="8547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E0BAD8B3-C410-7AFB-91AE-5D6F0E6EDD80}"/>
              </a:ext>
            </a:extLst>
          </p:cNvPr>
          <p:cNvGrpSpPr/>
          <p:nvPr/>
        </p:nvGrpSpPr>
        <p:grpSpPr>
          <a:xfrm>
            <a:off x="2926919" y="2860177"/>
            <a:ext cx="1962853" cy="434256"/>
            <a:chOff x="4039428" y="3305229"/>
            <a:chExt cx="944522" cy="226766"/>
          </a:xfrm>
        </p:grpSpPr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F3B1344A-1FE9-B6CD-09EE-0369DA383445}"/>
                </a:ext>
              </a:extLst>
            </p:cNvPr>
            <p:cNvSpPr txBox="1"/>
            <p:nvPr/>
          </p:nvSpPr>
          <p:spPr>
            <a:xfrm>
              <a:off x="40394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A5627EAC-658D-3C2E-DFBB-5AE0056DE449}"/>
                </a:ext>
              </a:extLst>
            </p:cNvPr>
            <p:cNvSpPr txBox="1"/>
            <p:nvPr/>
          </p:nvSpPr>
          <p:spPr>
            <a:xfrm>
              <a:off x="4304016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7C103526-C63B-2A4B-B12B-CDA744D9473B}"/>
                </a:ext>
              </a:extLst>
            </p:cNvPr>
            <p:cNvSpPr txBox="1"/>
            <p:nvPr/>
          </p:nvSpPr>
          <p:spPr>
            <a:xfrm>
              <a:off x="4568604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2C1F613-5226-3F69-357D-DA5A8431BFE6}"/>
                </a:ext>
              </a:extLst>
            </p:cNvPr>
            <p:cNvSpPr txBox="1"/>
            <p:nvPr/>
          </p:nvSpPr>
          <p:spPr>
            <a:xfrm>
              <a:off x="4812995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6" name="直线连接符 25">
            <a:extLst>
              <a:ext uri="{FF2B5EF4-FFF2-40B4-BE49-F238E27FC236}">
                <a16:creationId xmlns:a16="http://schemas.microsoft.com/office/drawing/2014/main" id="{2618428F-7C75-E522-4016-13218268364E}"/>
              </a:ext>
            </a:extLst>
          </p:cNvPr>
          <p:cNvCxnSpPr>
            <a:cxnSpLocks/>
          </p:cNvCxnSpPr>
          <p:nvPr/>
        </p:nvCxnSpPr>
        <p:spPr>
          <a:xfrm>
            <a:off x="2909616" y="2804433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线连接符 26">
            <a:extLst>
              <a:ext uri="{FF2B5EF4-FFF2-40B4-BE49-F238E27FC236}">
                <a16:creationId xmlns:a16="http://schemas.microsoft.com/office/drawing/2014/main" id="{FC1052F9-F837-CCCF-14A6-55F60BFF7335}"/>
              </a:ext>
            </a:extLst>
          </p:cNvPr>
          <p:cNvCxnSpPr>
            <a:cxnSpLocks/>
          </p:cNvCxnSpPr>
          <p:nvPr/>
        </p:nvCxnSpPr>
        <p:spPr>
          <a:xfrm>
            <a:off x="3989772" y="2804433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01EE182B-4141-C8D9-515D-83AF4C9525DA}"/>
              </a:ext>
            </a:extLst>
          </p:cNvPr>
          <p:cNvSpPr txBox="1"/>
          <p:nvPr/>
        </p:nvSpPr>
        <p:spPr>
          <a:xfrm>
            <a:off x="2882543" y="2349782"/>
            <a:ext cx="1040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C3807FC-C178-9670-D692-55E2BA689C21}"/>
              </a:ext>
            </a:extLst>
          </p:cNvPr>
          <p:cNvSpPr txBox="1"/>
          <p:nvPr/>
        </p:nvSpPr>
        <p:spPr>
          <a:xfrm>
            <a:off x="3923213" y="2349782"/>
            <a:ext cx="1141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5716D78A-C31A-8253-B6B6-D6D7623A1107}"/>
              </a:ext>
            </a:extLst>
          </p:cNvPr>
          <p:cNvGrpSpPr/>
          <p:nvPr/>
        </p:nvGrpSpPr>
        <p:grpSpPr>
          <a:xfrm>
            <a:off x="2007597" y="3187088"/>
            <a:ext cx="529864" cy="1291730"/>
            <a:chOff x="7236967" y="3246657"/>
            <a:chExt cx="529864" cy="1262736"/>
          </a:xfrm>
        </p:grpSpPr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BB5F1733-FFE5-7EA9-4977-D9C20088C662}"/>
                </a:ext>
              </a:extLst>
            </p:cNvPr>
            <p:cNvSpPr txBox="1"/>
            <p:nvPr/>
          </p:nvSpPr>
          <p:spPr>
            <a:xfrm>
              <a:off x="7236967" y="4158803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线连接符 49">
              <a:extLst>
                <a:ext uri="{FF2B5EF4-FFF2-40B4-BE49-F238E27FC236}">
                  <a16:creationId xmlns:a16="http://schemas.microsoft.com/office/drawing/2014/main" id="{049E957F-5A79-FF77-5FE4-49095958B6A7}"/>
                </a:ext>
              </a:extLst>
            </p:cNvPr>
            <p:cNvCxnSpPr>
              <a:cxnSpLocks/>
            </p:cNvCxnSpPr>
            <p:nvPr/>
          </p:nvCxnSpPr>
          <p:spPr>
            <a:xfrm>
              <a:off x="7654611" y="4346325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线连接符 50">
              <a:extLst>
                <a:ext uri="{FF2B5EF4-FFF2-40B4-BE49-F238E27FC236}">
                  <a16:creationId xmlns:a16="http://schemas.microsoft.com/office/drawing/2014/main" id="{415348F7-3CA0-BBEF-F96B-BDAE754B4631}"/>
                </a:ext>
              </a:extLst>
            </p:cNvPr>
            <p:cNvCxnSpPr>
              <a:cxnSpLocks/>
            </p:cNvCxnSpPr>
            <p:nvPr/>
          </p:nvCxnSpPr>
          <p:spPr>
            <a:xfrm>
              <a:off x="7654611" y="3996558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A578538C-6277-21C3-5BA1-F05FC1BAD544}"/>
                </a:ext>
              </a:extLst>
            </p:cNvPr>
            <p:cNvSpPr txBox="1"/>
            <p:nvPr/>
          </p:nvSpPr>
          <p:spPr>
            <a:xfrm>
              <a:off x="7236967" y="3846762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线连接符 68">
              <a:extLst>
                <a:ext uri="{FF2B5EF4-FFF2-40B4-BE49-F238E27FC236}">
                  <a16:creationId xmlns:a16="http://schemas.microsoft.com/office/drawing/2014/main" id="{1703AD53-ABBE-6C9D-12E5-A0FD58E0F78C}"/>
                </a:ext>
              </a:extLst>
            </p:cNvPr>
            <p:cNvCxnSpPr>
              <a:cxnSpLocks/>
            </p:cNvCxnSpPr>
            <p:nvPr/>
          </p:nvCxnSpPr>
          <p:spPr>
            <a:xfrm>
              <a:off x="7654611" y="3745447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286417CD-2ED5-7E1A-5454-FDF9837F351D}"/>
                </a:ext>
              </a:extLst>
            </p:cNvPr>
            <p:cNvSpPr txBox="1"/>
            <p:nvPr/>
          </p:nvSpPr>
          <p:spPr>
            <a:xfrm>
              <a:off x="7236967" y="3576314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直线连接符 74">
              <a:extLst>
                <a:ext uri="{FF2B5EF4-FFF2-40B4-BE49-F238E27FC236}">
                  <a16:creationId xmlns:a16="http://schemas.microsoft.com/office/drawing/2014/main" id="{A657C358-F13B-A9E1-1F9D-AD1784B67438}"/>
                </a:ext>
              </a:extLst>
            </p:cNvPr>
            <p:cNvCxnSpPr>
              <a:cxnSpLocks/>
            </p:cNvCxnSpPr>
            <p:nvPr/>
          </p:nvCxnSpPr>
          <p:spPr>
            <a:xfrm>
              <a:off x="7654611" y="3422650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8215D3BA-A293-F57B-BC35-EB3BCCFEF567}"/>
                </a:ext>
              </a:extLst>
            </p:cNvPr>
            <p:cNvSpPr txBox="1"/>
            <p:nvPr/>
          </p:nvSpPr>
          <p:spPr>
            <a:xfrm>
              <a:off x="7236967" y="3246657"/>
              <a:ext cx="39946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C7063665-624A-166D-92FF-368D4A3F917B}"/>
              </a:ext>
            </a:extLst>
          </p:cNvPr>
          <p:cNvGrpSpPr/>
          <p:nvPr/>
        </p:nvGrpSpPr>
        <p:grpSpPr>
          <a:xfrm>
            <a:off x="9019538" y="4998413"/>
            <a:ext cx="2106667" cy="1094920"/>
            <a:chOff x="9552163" y="5078195"/>
            <a:chExt cx="2106667" cy="1094920"/>
          </a:xfrm>
        </p:grpSpPr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53D31352-C5DF-7501-29AF-70DF350395FB}"/>
                </a:ext>
              </a:extLst>
            </p:cNvPr>
            <p:cNvSpPr txBox="1"/>
            <p:nvPr/>
          </p:nvSpPr>
          <p:spPr>
            <a:xfrm>
              <a:off x="9552163" y="5078195"/>
              <a:ext cx="8114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BC60BAFD-98B9-E136-9B0D-0A7E60B8C364}"/>
                </a:ext>
              </a:extLst>
            </p:cNvPr>
            <p:cNvSpPr txBox="1"/>
            <p:nvPr/>
          </p:nvSpPr>
          <p:spPr>
            <a:xfrm>
              <a:off x="9552163" y="5465229"/>
              <a:ext cx="2106667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E circ-EGFR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4533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071C0F-E92F-70D5-7BC9-718A191DC8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组合 90">
            <a:extLst>
              <a:ext uri="{FF2B5EF4-FFF2-40B4-BE49-F238E27FC236}">
                <a16:creationId xmlns:a16="http://schemas.microsoft.com/office/drawing/2014/main" id="{EC15A741-A1EF-A770-F3EB-3150EC8F64AD}"/>
              </a:ext>
            </a:extLst>
          </p:cNvPr>
          <p:cNvGrpSpPr/>
          <p:nvPr/>
        </p:nvGrpSpPr>
        <p:grpSpPr>
          <a:xfrm>
            <a:off x="6863754" y="2048163"/>
            <a:ext cx="4707913" cy="2041894"/>
            <a:chOff x="7285268" y="-156696"/>
            <a:chExt cx="4707913" cy="2041894"/>
          </a:xfrm>
        </p:grpSpPr>
        <p:pic>
          <p:nvPicPr>
            <p:cNvPr id="87" name="图片 86" descr="图片包含 室内, 插口, 照片, 旧&#10;&#10;AI 生成的内容可能不正确。">
              <a:extLst>
                <a:ext uri="{FF2B5EF4-FFF2-40B4-BE49-F238E27FC236}">
                  <a16:creationId xmlns:a16="http://schemas.microsoft.com/office/drawing/2014/main" id="{BBD390F7-5172-9A49-59E5-4407428CD1BE}"/>
                </a:ext>
              </a:extLst>
            </p:cNvPr>
            <p:cNvPicPr>
              <a:picLocks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258460" y="733198"/>
              <a:ext cx="2880000" cy="1152000"/>
            </a:xfrm>
            <a:prstGeom prst="rect">
              <a:avLst/>
            </a:prstGeom>
          </p:spPr>
        </p:pic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3E7185B-44EF-5D88-C222-796CE74465B1}"/>
                </a:ext>
              </a:extLst>
            </p:cNvPr>
            <p:cNvSpPr txBox="1"/>
            <p:nvPr/>
          </p:nvSpPr>
          <p:spPr>
            <a:xfrm>
              <a:off x="7285268" y="1109143"/>
              <a:ext cx="86914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B3584320-BC78-C375-0D2F-3EF1ED2F696D}"/>
                </a:ext>
              </a:extLst>
            </p:cNvPr>
            <p:cNvSpPr txBox="1"/>
            <p:nvPr/>
          </p:nvSpPr>
          <p:spPr>
            <a:xfrm>
              <a:off x="11138460" y="1109143"/>
              <a:ext cx="85472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7" name="组合 56">
              <a:extLst>
                <a:ext uri="{FF2B5EF4-FFF2-40B4-BE49-F238E27FC236}">
                  <a16:creationId xmlns:a16="http://schemas.microsoft.com/office/drawing/2014/main" id="{8768A93C-A95F-B0ED-BB1B-6560ED9B3553}"/>
                </a:ext>
              </a:extLst>
            </p:cNvPr>
            <p:cNvGrpSpPr/>
            <p:nvPr/>
          </p:nvGrpSpPr>
          <p:grpSpPr>
            <a:xfrm>
              <a:off x="8732867" y="353699"/>
              <a:ext cx="1962853" cy="434256"/>
              <a:chOff x="4039428" y="3305229"/>
              <a:chExt cx="944522" cy="226766"/>
            </a:xfrm>
          </p:grpSpPr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E373CC65-41D8-E10A-96EC-F42B30189400}"/>
                  </a:ext>
                </a:extLst>
              </p:cNvPr>
              <p:cNvSpPr txBox="1"/>
              <p:nvPr/>
            </p:nvSpPr>
            <p:spPr>
              <a:xfrm>
                <a:off x="4039428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E8D945AB-2009-EA26-C6BC-0B4DDEB73E47}"/>
                  </a:ext>
                </a:extLst>
              </p:cNvPr>
              <p:cNvSpPr txBox="1"/>
              <p:nvPr/>
            </p:nvSpPr>
            <p:spPr>
              <a:xfrm>
                <a:off x="4304016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67306F3E-DA8F-FDFB-08A5-D260ABEF41E1}"/>
                  </a:ext>
                </a:extLst>
              </p:cNvPr>
              <p:cNvSpPr txBox="1"/>
              <p:nvPr/>
            </p:nvSpPr>
            <p:spPr>
              <a:xfrm>
                <a:off x="4568604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42BC7DDC-8CC1-46D7-5F2A-D5333A2CE2B0}"/>
                  </a:ext>
                </a:extLst>
              </p:cNvPr>
              <p:cNvSpPr txBox="1"/>
              <p:nvPr/>
            </p:nvSpPr>
            <p:spPr>
              <a:xfrm>
                <a:off x="4812995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9" name="直线连接符 68">
              <a:extLst>
                <a:ext uri="{FF2B5EF4-FFF2-40B4-BE49-F238E27FC236}">
                  <a16:creationId xmlns:a16="http://schemas.microsoft.com/office/drawing/2014/main" id="{3DDECAF4-37B9-EBA0-F260-6B17010DCD99}"/>
                </a:ext>
              </a:extLst>
            </p:cNvPr>
            <p:cNvCxnSpPr>
              <a:cxnSpLocks/>
            </p:cNvCxnSpPr>
            <p:nvPr/>
          </p:nvCxnSpPr>
          <p:spPr>
            <a:xfrm>
              <a:off x="8715564" y="297955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线连接符 69">
              <a:extLst>
                <a:ext uri="{FF2B5EF4-FFF2-40B4-BE49-F238E27FC236}">
                  <a16:creationId xmlns:a16="http://schemas.microsoft.com/office/drawing/2014/main" id="{08CD0D83-D970-5766-0038-F4517EDE6470}"/>
                </a:ext>
              </a:extLst>
            </p:cNvPr>
            <p:cNvCxnSpPr>
              <a:cxnSpLocks/>
            </p:cNvCxnSpPr>
            <p:nvPr/>
          </p:nvCxnSpPr>
          <p:spPr>
            <a:xfrm>
              <a:off x="9795720" y="297955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AE94230B-D0A4-2FBA-04D6-43375D0C457F}"/>
                </a:ext>
              </a:extLst>
            </p:cNvPr>
            <p:cNvSpPr txBox="1"/>
            <p:nvPr/>
          </p:nvSpPr>
          <p:spPr>
            <a:xfrm>
              <a:off x="8874440" y="-156696"/>
              <a:ext cx="6687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Fi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447BFA36-3316-37FC-B1F5-2AC736D35779}"/>
                </a:ext>
              </a:extLst>
            </p:cNvPr>
            <p:cNvSpPr txBox="1"/>
            <p:nvPr/>
          </p:nvSpPr>
          <p:spPr>
            <a:xfrm>
              <a:off x="9858205" y="-156696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W48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66475970-597A-1678-61EB-D81E3EF07B8B}"/>
              </a:ext>
            </a:extLst>
          </p:cNvPr>
          <p:cNvGrpSpPr/>
          <p:nvPr/>
        </p:nvGrpSpPr>
        <p:grpSpPr>
          <a:xfrm>
            <a:off x="964588" y="2150935"/>
            <a:ext cx="5131412" cy="2172315"/>
            <a:chOff x="984124" y="53093"/>
            <a:chExt cx="5131412" cy="2172315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1B5D8EF-C49A-78C5-4F6D-C7DBA8A6F6D0}"/>
                </a:ext>
              </a:extLst>
            </p:cNvPr>
            <p:cNvSpPr txBox="1"/>
            <p:nvPr/>
          </p:nvSpPr>
          <p:spPr>
            <a:xfrm>
              <a:off x="984124" y="1318932"/>
              <a:ext cx="86914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0C433BE-D43A-3EDB-C132-1D0AE5BC97E1}"/>
                </a:ext>
              </a:extLst>
            </p:cNvPr>
            <p:cNvSpPr txBox="1"/>
            <p:nvPr/>
          </p:nvSpPr>
          <p:spPr>
            <a:xfrm>
              <a:off x="5260815" y="1318932"/>
              <a:ext cx="85472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49389BB2-4606-D414-1A91-3662D278256D}"/>
                </a:ext>
              </a:extLst>
            </p:cNvPr>
            <p:cNvSpPr txBox="1"/>
            <p:nvPr/>
          </p:nvSpPr>
          <p:spPr>
            <a:xfrm>
              <a:off x="2993825" y="563488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AA6E6DF6-BBC3-E150-680B-5C74CCD82382}"/>
                </a:ext>
              </a:extLst>
            </p:cNvPr>
            <p:cNvSpPr txBox="1"/>
            <p:nvPr/>
          </p:nvSpPr>
          <p:spPr>
            <a:xfrm>
              <a:off x="3543677" y="563488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DF58ABF1-85FC-0A52-D8D0-3A34769B759D}"/>
                </a:ext>
              </a:extLst>
            </p:cNvPr>
            <p:cNvSpPr txBox="1"/>
            <p:nvPr/>
          </p:nvSpPr>
          <p:spPr>
            <a:xfrm>
              <a:off x="4160435" y="563488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E2362C9B-2907-A09D-EC59-A1C908EE70B2}"/>
                </a:ext>
              </a:extLst>
            </p:cNvPr>
            <p:cNvSpPr txBox="1"/>
            <p:nvPr/>
          </p:nvSpPr>
          <p:spPr>
            <a:xfrm>
              <a:off x="4668315" y="563488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线连接符 17">
              <a:extLst>
                <a:ext uri="{FF2B5EF4-FFF2-40B4-BE49-F238E27FC236}">
                  <a16:creationId xmlns:a16="http://schemas.microsoft.com/office/drawing/2014/main" id="{F6CF4871-FB90-927F-1301-6972776D03ED}"/>
                </a:ext>
              </a:extLst>
            </p:cNvPr>
            <p:cNvCxnSpPr>
              <a:cxnSpLocks/>
            </p:cNvCxnSpPr>
            <p:nvPr/>
          </p:nvCxnSpPr>
          <p:spPr>
            <a:xfrm>
              <a:off x="2976522" y="507744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线连接符 26">
              <a:extLst>
                <a:ext uri="{FF2B5EF4-FFF2-40B4-BE49-F238E27FC236}">
                  <a16:creationId xmlns:a16="http://schemas.microsoft.com/office/drawing/2014/main" id="{91B0D324-EB96-5D68-2838-B17B695454EE}"/>
                </a:ext>
              </a:extLst>
            </p:cNvPr>
            <p:cNvCxnSpPr>
              <a:cxnSpLocks/>
            </p:cNvCxnSpPr>
            <p:nvPr/>
          </p:nvCxnSpPr>
          <p:spPr>
            <a:xfrm>
              <a:off x="4123584" y="507744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35D6A4B-1D67-8737-24C1-B68F9C422DEB}"/>
                </a:ext>
              </a:extLst>
            </p:cNvPr>
            <p:cNvSpPr txBox="1"/>
            <p:nvPr/>
          </p:nvSpPr>
          <p:spPr>
            <a:xfrm>
              <a:off x="3135398" y="53093"/>
              <a:ext cx="6687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Fi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BB95CE0B-8A65-5684-2559-D93703BE9B68}"/>
                </a:ext>
              </a:extLst>
            </p:cNvPr>
            <p:cNvSpPr txBox="1"/>
            <p:nvPr/>
          </p:nvSpPr>
          <p:spPr>
            <a:xfrm>
              <a:off x="4186069" y="53093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W48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2EE0A0E2-589E-826B-112D-2BAF1D538FD8}"/>
                </a:ext>
              </a:extLst>
            </p:cNvPr>
            <p:cNvSpPr txBox="1"/>
            <p:nvPr/>
          </p:nvSpPr>
          <p:spPr>
            <a:xfrm>
              <a:off x="1846448" y="1699498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线连接符 34">
              <a:extLst>
                <a:ext uri="{FF2B5EF4-FFF2-40B4-BE49-F238E27FC236}">
                  <a16:creationId xmlns:a16="http://schemas.microsoft.com/office/drawing/2014/main" id="{A353FBE9-1D63-7D30-A267-48474A665742}"/>
                </a:ext>
              </a:extLst>
            </p:cNvPr>
            <p:cNvCxnSpPr>
              <a:cxnSpLocks/>
            </p:cNvCxnSpPr>
            <p:nvPr/>
          </p:nvCxnSpPr>
          <p:spPr>
            <a:xfrm>
              <a:off x="2264092" y="1849312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线连接符 35">
              <a:extLst>
                <a:ext uri="{FF2B5EF4-FFF2-40B4-BE49-F238E27FC236}">
                  <a16:creationId xmlns:a16="http://schemas.microsoft.com/office/drawing/2014/main" id="{3BED0673-B03A-BDEF-722F-1B1D8FBB41E0}"/>
                </a:ext>
              </a:extLst>
            </p:cNvPr>
            <p:cNvCxnSpPr>
              <a:cxnSpLocks/>
            </p:cNvCxnSpPr>
            <p:nvPr/>
          </p:nvCxnSpPr>
          <p:spPr>
            <a:xfrm>
              <a:off x="2264092" y="1640950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60CB9ABF-0894-678E-66E7-B605AA4DDBED}"/>
                </a:ext>
              </a:extLst>
            </p:cNvPr>
            <p:cNvSpPr txBox="1"/>
            <p:nvPr/>
          </p:nvSpPr>
          <p:spPr>
            <a:xfrm>
              <a:off x="1846448" y="1491154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线连接符 37">
              <a:extLst>
                <a:ext uri="{FF2B5EF4-FFF2-40B4-BE49-F238E27FC236}">
                  <a16:creationId xmlns:a16="http://schemas.microsoft.com/office/drawing/2014/main" id="{FDE19D57-639C-20AD-DD96-6B03497ED322}"/>
                </a:ext>
              </a:extLst>
            </p:cNvPr>
            <p:cNvCxnSpPr>
              <a:cxnSpLocks/>
            </p:cNvCxnSpPr>
            <p:nvPr/>
          </p:nvCxnSpPr>
          <p:spPr>
            <a:xfrm>
              <a:off x="2264092" y="1389839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EEE57FD3-9FD6-76FD-0965-0190499266EB}"/>
                </a:ext>
              </a:extLst>
            </p:cNvPr>
            <p:cNvSpPr txBox="1"/>
            <p:nvPr/>
          </p:nvSpPr>
          <p:spPr>
            <a:xfrm>
              <a:off x="1846448" y="1220706"/>
              <a:ext cx="446917" cy="350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线连接符 39">
              <a:extLst>
                <a:ext uri="{FF2B5EF4-FFF2-40B4-BE49-F238E27FC236}">
                  <a16:creationId xmlns:a16="http://schemas.microsoft.com/office/drawing/2014/main" id="{CB02412F-9928-981D-C110-FDE02F23DEB8}"/>
                </a:ext>
              </a:extLst>
            </p:cNvPr>
            <p:cNvCxnSpPr>
              <a:cxnSpLocks/>
            </p:cNvCxnSpPr>
            <p:nvPr/>
          </p:nvCxnSpPr>
          <p:spPr>
            <a:xfrm>
              <a:off x="2264092" y="1095507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FEECDF2-A986-3F06-2AA4-54975AB6CB98}"/>
                </a:ext>
              </a:extLst>
            </p:cNvPr>
            <p:cNvSpPr txBox="1"/>
            <p:nvPr/>
          </p:nvSpPr>
          <p:spPr>
            <a:xfrm>
              <a:off x="1846448" y="919514"/>
              <a:ext cx="39946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3" name="图片 52" descr="图片包含 插口, 室内, 照片, 旧&#10;&#10;AI 生成的内容可能不正确。">
              <a:extLst>
                <a:ext uri="{FF2B5EF4-FFF2-40B4-BE49-F238E27FC236}">
                  <a16:creationId xmlns:a16="http://schemas.microsoft.com/office/drawing/2014/main" id="{AABFC84D-5265-3BD1-A832-25D600DA8A4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hq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2349959" y="971268"/>
              <a:ext cx="2880000" cy="1152000"/>
            </a:xfrm>
            <a:prstGeom prst="rect">
              <a:avLst/>
            </a:prstGeom>
          </p:spPr>
        </p:pic>
        <p:cxnSp>
          <p:nvCxnSpPr>
            <p:cNvPr id="88" name="直线连接符 87">
              <a:extLst>
                <a:ext uri="{FF2B5EF4-FFF2-40B4-BE49-F238E27FC236}">
                  <a16:creationId xmlns:a16="http://schemas.microsoft.com/office/drawing/2014/main" id="{6796243F-D735-A309-309E-AD6FD9152FBB}"/>
                </a:ext>
              </a:extLst>
            </p:cNvPr>
            <p:cNvCxnSpPr>
              <a:cxnSpLocks/>
            </p:cNvCxnSpPr>
            <p:nvPr/>
          </p:nvCxnSpPr>
          <p:spPr>
            <a:xfrm>
              <a:off x="2254665" y="2077128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2B810999-9894-B87E-CC42-6275F0B8CBA1}"/>
                </a:ext>
              </a:extLst>
            </p:cNvPr>
            <p:cNvSpPr txBox="1"/>
            <p:nvPr/>
          </p:nvSpPr>
          <p:spPr>
            <a:xfrm>
              <a:off x="1846448" y="1902243"/>
              <a:ext cx="39946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E41AFF8D-ABC9-41D7-D8B3-AB444578F86E}"/>
              </a:ext>
            </a:extLst>
          </p:cNvPr>
          <p:cNvGrpSpPr/>
          <p:nvPr/>
        </p:nvGrpSpPr>
        <p:grpSpPr>
          <a:xfrm>
            <a:off x="9233639" y="4935572"/>
            <a:ext cx="2249334" cy="1094920"/>
            <a:chOff x="9552163" y="5078195"/>
            <a:chExt cx="2249334" cy="1094920"/>
          </a:xfrm>
        </p:grpSpPr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B4BF22EF-C099-5E32-8307-32174902F922}"/>
                </a:ext>
              </a:extLst>
            </p:cNvPr>
            <p:cNvSpPr txBox="1"/>
            <p:nvPr/>
          </p:nvSpPr>
          <p:spPr>
            <a:xfrm>
              <a:off x="9552163" y="5078195"/>
              <a:ext cx="8114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E33F9086-EE50-A98D-BF2E-868C5CC076A8}"/>
                </a:ext>
              </a:extLst>
            </p:cNvPr>
            <p:cNvSpPr txBox="1"/>
            <p:nvPr/>
          </p:nvSpPr>
          <p:spPr>
            <a:xfrm>
              <a:off x="9552163" y="5465229"/>
              <a:ext cx="2249334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E miR-942-3p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627486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FDCDDF-61D5-F21B-78FA-6883E19478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A37D20D7-C500-CF23-F8E3-C4B7B6242D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547264" y="2772033"/>
            <a:ext cx="2778502" cy="131393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BF88942-B281-B21E-79E5-51268C4FB640}"/>
              </a:ext>
            </a:extLst>
          </p:cNvPr>
          <p:cNvSpPr txBox="1"/>
          <p:nvPr/>
        </p:nvSpPr>
        <p:spPr>
          <a:xfrm>
            <a:off x="895331" y="3118553"/>
            <a:ext cx="9877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6A56B63-E899-DC59-FCBF-73DEC173191D}"/>
              </a:ext>
            </a:extLst>
          </p:cNvPr>
          <p:cNvSpPr txBox="1"/>
          <p:nvPr/>
        </p:nvSpPr>
        <p:spPr>
          <a:xfrm>
            <a:off x="5325766" y="3118553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961B193-A521-094F-757A-603415E91AFF}"/>
              </a:ext>
            </a:extLst>
          </p:cNvPr>
          <p:cNvSpPr txBox="1"/>
          <p:nvPr/>
        </p:nvSpPr>
        <p:spPr>
          <a:xfrm>
            <a:off x="3058776" y="2363109"/>
            <a:ext cx="355269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D1D2EFF-9147-4D9E-5BB8-2EEE943211D8}"/>
              </a:ext>
            </a:extLst>
          </p:cNvPr>
          <p:cNvSpPr txBox="1"/>
          <p:nvPr/>
        </p:nvSpPr>
        <p:spPr>
          <a:xfrm>
            <a:off x="3608628" y="2363109"/>
            <a:ext cx="355269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A2E5F59-DFDF-FB3A-5FA1-AB94AD7F3495}"/>
              </a:ext>
            </a:extLst>
          </p:cNvPr>
          <p:cNvSpPr txBox="1"/>
          <p:nvPr/>
        </p:nvSpPr>
        <p:spPr>
          <a:xfrm>
            <a:off x="4119508" y="2363109"/>
            <a:ext cx="355269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090BC8D-83ED-99CD-8004-77CEEFB7756E}"/>
              </a:ext>
            </a:extLst>
          </p:cNvPr>
          <p:cNvSpPr txBox="1"/>
          <p:nvPr/>
        </p:nvSpPr>
        <p:spPr>
          <a:xfrm>
            <a:off x="4627388" y="2363109"/>
            <a:ext cx="355269" cy="4342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线连接符 16">
            <a:extLst>
              <a:ext uri="{FF2B5EF4-FFF2-40B4-BE49-F238E27FC236}">
                <a16:creationId xmlns:a16="http://schemas.microsoft.com/office/drawing/2014/main" id="{F5CDC95D-1F61-3215-FBDC-B86BE9B4C81B}"/>
              </a:ext>
            </a:extLst>
          </p:cNvPr>
          <p:cNvCxnSpPr>
            <a:cxnSpLocks/>
          </p:cNvCxnSpPr>
          <p:nvPr/>
        </p:nvCxnSpPr>
        <p:spPr>
          <a:xfrm>
            <a:off x="3041473" y="2307365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线连接符 17">
            <a:extLst>
              <a:ext uri="{FF2B5EF4-FFF2-40B4-BE49-F238E27FC236}">
                <a16:creationId xmlns:a16="http://schemas.microsoft.com/office/drawing/2014/main" id="{7807E239-0FA9-9D87-6553-0FA88F284AC7}"/>
              </a:ext>
            </a:extLst>
          </p:cNvPr>
          <p:cNvCxnSpPr>
            <a:cxnSpLocks/>
          </p:cNvCxnSpPr>
          <p:nvPr/>
        </p:nvCxnSpPr>
        <p:spPr>
          <a:xfrm>
            <a:off x="4082657" y="2307365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9540F9B1-2ADC-378A-0C8A-B781ABB53611}"/>
              </a:ext>
            </a:extLst>
          </p:cNvPr>
          <p:cNvSpPr txBox="1"/>
          <p:nvPr/>
        </p:nvSpPr>
        <p:spPr>
          <a:xfrm>
            <a:off x="3200349" y="1852714"/>
            <a:ext cx="6687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iFi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DFEB9F1-1E4D-BF8B-CDFD-30E354D595D4}"/>
              </a:ext>
            </a:extLst>
          </p:cNvPr>
          <p:cNvSpPr txBox="1"/>
          <p:nvPr/>
        </p:nvSpPr>
        <p:spPr>
          <a:xfrm>
            <a:off x="4145142" y="1852714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W48</a:t>
            </a:r>
            <a:endParaRPr kumimoji="1"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6F49C4E-A77C-FC2D-E311-1D3CE110DD85}"/>
              </a:ext>
            </a:extLst>
          </p:cNvPr>
          <p:cNvSpPr txBox="1"/>
          <p:nvPr/>
        </p:nvSpPr>
        <p:spPr>
          <a:xfrm>
            <a:off x="2027511" y="3806289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线连接符 28">
            <a:extLst>
              <a:ext uri="{FF2B5EF4-FFF2-40B4-BE49-F238E27FC236}">
                <a16:creationId xmlns:a16="http://schemas.microsoft.com/office/drawing/2014/main" id="{7404A6FD-7FF2-49A8-C1F6-E3DDDA6F6EA3}"/>
              </a:ext>
            </a:extLst>
          </p:cNvPr>
          <p:cNvCxnSpPr>
            <a:cxnSpLocks/>
          </p:cNvCxnSpPr>
          <p:nvPr/>
        </p:nvCxnSpPr>
        <p:spPr>
          <a:xfrm>
            <a:off x="2445155" y="3977874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线连接符 29">
            <a:extLst>
              <a:ext uri="{FF2B5EF4-FFF2-40B4-BE49-F238E27FC236}">
                <a16:creationId xmlns:a16="http://schemas.microsoft.com/office/drawing/2014/main" id="{74354650-D30D-2488-FD45-7C7EC5BC6054}"/>
              </a:ext>
            </a:extLst>
          </p:cNvPr>
          <p:cNvCxnSpPr>
            <a:cxnSpLocks/>
          </p:cNvCxnSpPr>
          <p:nvPr/>
        </p:nvCxnSpPr>
        <p:spPr>
          <a:xfrm>
            <a:off x="2445155" y="354216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0C002FF2-6250-F5BC-8A39-A370F7A70F00}"/>
              </a:ext>
            </a:extLst>
          </p:cNvPr>
          <p:cNvSpPr txBox="1"/>
          <p:nvPr/>
        </p:nvSpPr>
        <p:spPr>
          <a:xfrm>
            <a:off x="2027511" y="3392373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线连接符 34">
            <a:extLst>
              <a:ext uri="{FF2B5EF4-FFF2-40B4-BE49-F238E27FC236}">
                <a16:creationId xmlns:a16="http://schemas.microsoft.com/office/drawing/2014/main" id="{55BBF17F-DA9C-4DB9-19C6-22071402CAAE}"/>
              </a:ext>
            </a:extLst>
          </p:cNvPr>
          <p:cNvCxnSpPr>
            <a:cxnSpLocks/>
          </p:cNvCxnSpPr>
          <p:nvPr/>
        </p:nvCxnSpPr>
        <p:spPr>
          <a:xfrm>
            <a:off x="2445155" y="3233002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67A46F03-D481-4731-D190-7815E8849A7C}"/>
              </a:ext>
            </a:extLst>
          </p:cNvPr>
          <p:cNvSpPr txBox="1"/>
          <p:nvPr/>
        </p:nvSpPr>
        <p:spPr>
          <a:xfrm>
            <a:off x="2027511" y="3063869"/>
            <a:ext cx="446917" cy="350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线连接符 36">
            <a:extLst>
              <a:ext uri="{FF2B5EF4-FFF2-40B4-BE49-F238E27FC236}">
                <a16:creationId xmlns:a16="http://schemas.microsoft.com/office/drawing/2014/main" id="{CAE4B61F-A637-CBD3-32A6-7495140AFC55}"/>
              </a:ext>
            </a:extLst>
          </p:cNvPr>
          <p:cNvCxnSpPr>
            <a:cxnSpLocks/>
          </p:cNvCxnSpPr>
          <p:nvPr/>
        </p:nvCxnSpPr>
        <p:spPr>
          <a:xfrm>
            <a:off x="2445155" y="2838272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7FEF0EAC-EBED-E41E-C8CF-DBD0ACD0407A}"/>
              </a:ext>
            </a:extLst>
          </p:cNvPr>
          <p:cNvSpPr txBox="1"/>
          <p:nvPr/>
        </p:nvSpPr>
        <p:spPr>
          <a:xfrm>
            <a:off x="2027511" y="2676793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AB0ADEFA-C2FB-4A84-D777-7A6E63020C02}"/>
              </a:ext>
            </a:extLst>
          </p:cNvPr>
          <p:cNvGrpSpPr/>
          <p:nvPr/>
        </p:nvGrpSpPr>
        <p:grpSpPr>
          <a:xfrm>
            <a:off x="6906261" y="1799613"/>
            <a:ext cx="4488532" cy="1665949"/>
            <a:chOff x="7541500" y="1732366"/>
            <a:chExt cx="4488532" cy="1665949"/>
          </a:xfrm>
        </p:grpSpPr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EBCA6019-6B68-3A70-45E5-EA34AFF2879D}"/>
                </a:ext>
              </a:extLst>
            </p:cNvPr>
            <p:cNvSpPr txBox="1"/>
            <p:nvPr/>
          </p:nvSpPr>
          <p:spPr>
            <a:xfrm>
              <a:off x="7541500" y="2998205"/>
              <a:ext cx="9877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C6116357-9AF9-DC12-50F0-16F30DA5B012}"/>
                </a:ext>
              </a:extLst>
            </p:cNvPr>
            <p:cNvSpPr txBox="1"/>
            <p:nvPr/>
          </p:nvSpPr>
          <p:spPr>
            <a:xfrm>
              <a:off x="11175311" y="2998205"/>
              <a:ext cx="85472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F350681E-43F6-96F4-9C13-3F50787CBC81}"/>
                </a:ext>
              </a:extLst>
            </p:cNvPr>
            <p:cNvSpPr txBox="1"/>
            <p:nvPr/>
          </p:nvSpPr>
          <p:spPr>
            <a:xfrm>
              <a:off x="8908321" y="2242761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D50D97AD-0D4F-E155-C212-7B66932CD71B}"/>
                </a:ext>
              </a:extLst>
            </p:cNvPr>
            <p:cNvSpPr txBox="1"/>
            <p:nvPr/>
          </p:nvSpPr>
          <p:spPr>
            <a:xfrm>
              <a:off x="9458173" y="2242761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DE1A67EE-F65E-A565-35F5-405308F6E8BF}"/>
                </a:ext>
              </a:extLst>
            </p:cNvPr>
            <p:cNvSpPr txBox="1"/>
            <p:nvPr/>
          </p:nvSpPr>
          <p:spPr>
            <a:xfrm>
              <a:off x="9969053" y="2242761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F4BF06B4-19FA-9E83-12D0-4B1A2ABFEC5D}"/>
                </a:ext>
              </a:extLst>
            </p:cNvPr>
            <p:cNvSpPr txBox="1"/>
            <p:nvPr/>
          </p:nvSpPr>
          <p:spPr>
            <a:xfrm>
              <a:off x="10476933" y="2242761"/>
              <a:ext cx="355269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直线连接符 69">
              <a:extLst>
                <a:ext uri="{FF2B5EF4-FFF2-40B4-BE49-F238E27FC236}">
                  <a16:creationId xmlns:a16="http://schemas.microsoft.com/office/drawing/2014/main" id="{48BF946C-376E-B92C-380E-5172D63CACE9}"/>
                </a:ext>
              </a:extLst>
            </p:cNvPr>
            <p:cNvCxnSpPr>
              <a:cxnSpLocks/>
            </p:cNvCxnSpPr>
            <p:nvPr/>
          </p:nvCxnSpPr>
          <p:spPr>
            <a:xfrm>
              <a:off x="8891018" y="2187017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线连接符 70">
              <a:extLst>
                <a:ext uri="{FF2B5EF4-FFF2-40B4-BE49-F238E27FC236}">
                  <a16:creationId xmlns:a16="http://schemas.microsoft.com/office/drawing/2014/main" id="{812D1E38-92DB-E93F-2327-ABE3AAD2E43E}"/>
                </a:ext>
              </a:extLst>
            </p:cNvPr>
            <p:cNvCxnSpPr>
              <a:cxnSpLocks/>
            </p:cNvCxnSpPr>
            <p:nvPr/>
          </p:nvCxnSpPr>
          <p:spPr>
            <a:xfrm>
              <a:off x="9932202" y="2187017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A794FA63-17F3-0B46-058B-A26872C05A0F}"/>
                </a:ext>
              </a:extLst>
            </p:cNvPr>
            <p:cNvSpPr txBox="1"/>
            <p:nvPr/>
          </p:nvSpPr>
          <p:spPr>
            <a:xfrm>
              <a:off x="9049894" y="1732366"/>
              <a:ext cx="6687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Fi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B998FEE8-38B2-F58B-5BC6-50FBC47128AB}"/>
                </a:ext>
              </a:extLst>
            </p:cNvPr>
            <p:cNvSpPr txBox="1"/>
            <p:nvPr/>
          </p:nvSpPr>
          <p:spPr>
            <a:xfrm>
              <a:off x="9994687" y="1732366"/>
              <a:ext cx="8835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W48</a:t>
              </a:r>
              <a:endParaRPr kumimoji="1"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0F6B74B6-1C0C-C7AF-35E9-D79D922BE44E}"/>
              </a:ext>
            </a:extLst>
          </p:cNvPr>
          <p:cNvGrpSpPr/>
          <p:nvPr/>
        </p:nvGrpSpPr>
        <p:grpSpPr>
          <a:xfrm>
            <a:off x="9233639" y="4935572"/>
            <a:ext cx="2249334" cy="1094920"/>
            <a:chOff x="9552163" y="5078195"/>
            <a:chExt cx="2249334" cy="1094920"/>
          </a:xfrm>
        </p:grpSpPr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382854CA-06F9-892A-7B80-4B63B31A99E4}"/>
                </a:ext>
              </a:extLst>
            </p:cNvPr>
            <p:cNvSpPr txBox="1"/>
            <p:nvPr/>
          </p:nvSpPr>
          <p:spPr>
            <a:xfrm>
              <a:off x="9552163" y="5078195"/>
              <a:ext cx="8114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52E55EE1-F7F8-EBB2-5227-76A3BCDA4B92}"/>
                </a:ext>
              </a:extLst>
            </p:cNvPr>
            <p:cNvSpPr txBox="1"/>
            <p:nvPr/>
          </p:nvSpPr>
          <p:spPr>
            <a:xfrm>
              <a:off x="9552163" y="5465229"/>
              <a:ext cx="2249334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.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E miR-942-3p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" name="图片 6">
            <a:extLst>
              <a:ext uri="{FF2B5EF4-FFF2-40B4-BE49-F238E27FC236}">
                <a16:creationId xmlns:a16="http://schemas.microsoft.com/office/drawing/2014/main" id="{9B2D4C15-E430-2CBE-BFE4-BDB7744513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950107" y="2683666"/>
            <a:ext cx="2566840" cy="1301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339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118</Words>
  <Application>Microsoft Macintosh PowerPoint</Application>
  <PresentationFormat>宽屏</PresentationFormat>
  <Paragraphs>8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lei sui</dc:creator>
  <cp:lastModifiedBy>silei sui</cp:lastModifiedBy>
  <cp:revision>49</cp:revision>
  <dcterms:created xsi:type="dcterms:W3CDTF">2025-04-21T06:58:46Z</dcterms:created>
  <dcterms:modified xsi:type="dcterms:W3CDTF">2025-06-19T04:56:44Z</dcterms:modified>
</cp:coreProperties>
</file>